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66" y="10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D98E96-2A69-58F0-EAB6-7F814A27D4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2E55807-26CE-BA17-0FFE-A6CF9E06A6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99CC60-B537-5593-35AE-A7E5AEDC9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3F4A15-DEBA-17BF-1572-C6DEEE574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5B2C1A4-D7FF-1E8C-063C-48975ACBA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9742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7C2E8D-EEEB-44E7-AD0A-F21C31B021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67C3DF8-E93E-EE36-6484-729EB8D1AA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DA3E84-E37D-52EE-A1F4-69A0EF929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B77F2E-DAA8-83F8-8BCB-13B37D6EA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8FDCB2-1B22-0B22-79C3-1819F2CE1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3050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A59CA83-D124-9B66-CEBC-799009A579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F98AE93-0276-3363-09E7-307430F1EE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B330BE-6ED0-4858-AE31-D60C6550E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4D135B-A06B-BD18-EBFF-3D279BB01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8E8E7B-2AD5-AB94-6866-E74591EB6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790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40D50C-C0FB-8E5A-3F76-98E2B5E49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D18A10B-1826-27D7-61B5-F0097F3AD9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910E5F-16A4-8085-C5DD-EBE0F37B0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4B06FB-B850-F13F-D243-90DE1DF9C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1BA401-D986-C296-2103-205E1469B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8445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83359F-1966-2A76-D574-102B59C98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D53613-F8F8-56B7-A851-34EE3FB674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8852AC-BE11-0A92-B8A3-724224AA9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A7F1F0-C1C7-F3EB-86F1-63EEE88BD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DD96D3-00C3-5B03-1085-530303921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2030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F02475-23F2-31C0-7E2C-92B6F9437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DA60C38-1002-3C70-5A1D-ED824B498D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C75D34-A295-F52A-7A1C-94938D3BBC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F88F36B-1AC2-D0E5-B452-DB7BC76C3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8FBB475-E15D-9534-2ED9-F5B76E98C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362221-CF9D-45A1-AB5D-74ED89698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2965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3D191D-1277-9769-85DE-9CBC945B0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4FC7C1-A10F-067F-C9A0-F7243A2D64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9711910-2026-97CB-2F82-447F6874A3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2A5D70C-92F8-D822-ADE9-4FBD6CBAE5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3640E65-1A97-2BAE-FF2D-8A5D64A7AA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C7B8E33-2532-EF1F-D132-80709BF37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5C71A30-8774-D1BA-FE62-14B69ECDE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438C855-F7A1-8A5A-6DA7-56475A1FF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582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DBA67D-AB00-794C-5429-6CA31B55CF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D4B1F31-9DB5-2F90-9348-E6E876422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1E8484B-2A55-6122-A922-713D3C8DB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996C401-4460-2292-318D-00CA6DAC7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0857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1403085-C42F-5958-8A9B-0B44BFB1E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077352A-648F-7098-BC1A-B12D6F41F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BC5B920-97A4-A8D7-E402-AE2841769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1125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871E3F-BCF0-2DAE-5C2E-8CFC82337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B7C1B46-CA24-CF0E-F5A7-CC17D5C0C2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1A9195-6EDB-F01C-D70E-4634BC8C17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D1801D-7035-EC41-5BC5-5E90FA5BD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E3ACEAD-C9B7-2C9D-00B8-7984FE768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8A797A-B213-C595-DA71-A0FAEE7F8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638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BF9816-C18D-2FD4-482B-0F6495C050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15195C0-CECB-376B-B92D-1CEB2CAA32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2F19634-3E3E-EF67-FAC2-1BF32992F7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33F6C36-3225-ADF9-AD6A-B0A011349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419E53-B3C3-7C68-DA53-F140AF13B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3041D85-C7A4-DF73-CBFA-84DFF4F4C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8174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131E9A7-123E-80C2-D61B-98CC84669C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5CCEAD-7C02-AA60-0024-030C7413D3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95248E-D5D5-6A87-5FDD-761F23E10A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6C9552-2646-4AC2-832C-905004BD7EA1}" type="datetimeFigureOut">
              <a:rPr lang="zh-CN" altLang="en-US" smtClean="0"/>
              <a:t>2024/1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379DA6-CF7C-F4B5-E194-7FC4D9B207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75A2EF-C714-B73D-3C68-AC5689F9E7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6A9C2A-EDEF-4B1A-81C9-80A48F031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327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947496D7-9797-ACFB-4535-218E1113B112}"/>
              </a:ext>
            </a:extLst>
          </p:cNvPr>
          <p:cNvSpPr txBox="1"/>
          <p:nvPr/>
        </p:nvSpPr>
        <p:spPr>
          <a:xfrm>
            <a:off x="490312" y="398236"/>
            <a:ext cx="83312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: N-glycosylation analysis of </a:t>
            </a:r>
            <a:r>
              <a:rPr lang="en-US" altLang="zh-CN" sz="20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lWOX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.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6F8B746-1CCD-C106-5E0F-0EE481C317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5471" y="898108"/>
            <a:ext cx="8800154" cy="5959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8230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218FE45-E4BE-B1E2-B438-676F157360DC}"/>
              </a:ext>
            </a:extLst>
          </p:cNvPr>
          <p:cNvSpPr txBox="1"/>
          <p:nvPr/>
        </p:nvSpPr>
        <p:spPr>
          <a:xfrm>
            <a:off x="595086" y="398176"/>
            <a:ext cx="83312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. The hydrophily and hydrophobicity of </a:t>
            </a:r>
            <a:r>
              <a:rPr lang="en-US" altLang="zh-CN" sz="20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lWOX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tein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144EB98-7A5D-C77F-97D4-930255F0DF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1039" y="798286"/>
            <a:ext cx="4629921" cy="5344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89537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C38A38C-E224-6822-F429-B3DBF838D341}"/>
              </a:ext>
            </a:extLst>
          </p:cNvPr>
          <p:cNvSpPr txBox="1"/>
          <p:nvPr/>
        </p:nvSpPr>
        <p:spPr>
          <a:xfrm>
            <a:off x="595085" y="398176"/>
            <a:ext cx="990622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. Heatmap shows the correlations between WGCNA gene modules and tissue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4C4E513-A00F-9F77-0CD3-9F4E1A2C49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068" y="798286"/>
            <a:ext cx="6904793" cy="60060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8630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2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ue zhang</dc:creator>
  <cp:lastModifiedBy>yue zhang</cp:lastModifiedBy>
  <cp:revision>1</cp:revision>
  <dcterms:created xsi:type="dcterms:W3CDTF">2024-12-28T10:40:03Z</dcterms:created>
  <dcterms:modified xsi:type="dcterms:W3CDTF">2024-12-28T10:42:41Z</dcterms:modified>
</cp:coreProperties>
</file>